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71" r:id="rId2"/>
    <p:sldId id="27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834" autoAdjust="0"/>
  </p:normalViewPr>
  <p:slideViewPr>
    <p:cSldViewPr snapToGrid="0" showGuides="1">
      <p:cViewPr varScale="1">
        <p:scale>
          <a:sx n="91" d="100"/>
          <a:sy n="91" d="100"/>
        </p:scale>
        <p:origin x="1008" y="84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9224E4-3425-474B-97B7-67764060AE6F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A26547-7FDB-4922-9F9E-C7A90EB2C07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2357CD-6D55-426A-9A0D-B674DBFBA431}" type="datetimeFigureOut">
              <a:rPr lang="zh-CN" altLang="en-US" smtClean="0"/>
              <a:t>2020/2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076E6-CA5A-4919-ABFF-E2CE3A8F9C0A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143703" y="266863"/>
            <a:ext cx="14015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tachment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2" cstate="email"/>
          <a:srcRect r="1984"/>
          <a:stretch>
            <a:fillRect/>
          </a:stretch>
        </p:blipFill>
        <p:spPr>
          <a:xfrm>
            <a:off x="2765129" y="2071788"/>
            <a:ext cx="6123948" cy="234684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3081013" y="4786212"/>
            <a:ext cx="57572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Fig. S1 </a:t>
            </a:r>
            <a:r>
              <a:rPr lang="en-US" altLang="zh-CN" dirty="0"/>
              <a:t>Primary cortical neuron showed positive Tuj1 (red). 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2" cstate="email"/>
          <a:stretch>
            <a:fillRect/>
          </a:stretch>
        </p:blipFill>
        <p:spPr>
          <a:xfrm>
            <a:off x="3206846" y="1597579"/>
            <a:ext cx="5006129" cy="2693298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3007340" y="4649416"/>
            <a:ext cx="57781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/>
              <a:t>Fig. S2 </a:t>
            </a:r>
            <a:r>
              <a:rPr lang="en-US" altLang="zh-CN" dirty="0"/>
              <a:t>Device and example of the </a:t>
            </a:r>
            <a:r>
              <a:rPr lang="en-US" altLang="zh-CN" dirty="0" err="1"/>
              <a:t>modle</a:t>
            </a:r>
            <a:r>
              <a:rPr lang="en-US" altLang="zh-CN" dirty="0"/>
              <a:t> of the TBI in rats. </a:t>
            </a:r>
            <a:endParaRPr lang="zh-CN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imes new roman">
      <a:majorFont>
        <a:latin typeface="Times New Roman"/>
        <a:ea typeface="等线 Light"/>
        <a:cs typeface=""/>
      </a:majorFont>
      <a:minorFont>
        <a:latin typeface="Times New Roman"/>
        <a:ea typeface="等线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等线</vt:lpstr>
      <vt:lpstr>Arial</vt:lpstr>
      <vt:lpstr>Times New Roman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徐 洪杰</dc:creator>
  <cp:lastModifiedBy>Sean Thompson</cp:lastModifiedBy>
  <cp:revision>101</cp:revision>
  <dcterms:created xsi:type="dcterms:W3CDTF">2018-11-06T10:02:00Z</dcterms:created>
  <dcterms:modified xsi:type="dcterms:W3CDTF">2020-02-21T09:16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339</vt:lpwstr>
  </property>
</Properties>
</file>